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de-TZ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10"/>
    <p:restoredTop sz="95958"/>
  </p:normalViewPr>
  <p:slideViewPr>
    <p:cSldViewPr snapToGrid="0">
      <p:cViewPr varScale="1">
        <p:scale>
          <a:sx n="59" d="100"/>
          <a:sy n="59" d="100"/>
        </p:scale>
        <p:origin x="96" y="4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703A5DFA-8225-6E6A-26CE-FB57EF171B1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  <a:endParaRPr lang="de-TZ"/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CA2023C1-88B5-D855-CA62-2D48E7176F3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  <a:endParaRPr lang="de-TZ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90E93DDB-FFFC-68B8-137D-B185266BD0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A24BA7-D115-7E4E-9003-74E1D667B184}" type="datetimeFigureOut">
              <a:rPr lang="de-TZ" smtClean="0"/>
              <a:t>11/14/2025</a:t>
            </a:fld>
            <a:endParaRPr lang="de-TZ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A3D3776D-4BF5-2241-62A6-26AFE03D38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TZ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0A6D888B-15CD-DE5D-4048-300C610C27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E72AA4-F2F9-E048-B08F-8E3A8D02451E}" type="slidenum">
              <a:rPr lang="de-TZ" smtClean="0"/>
              <a:t>‹#›</a:t>
            </a:fld>
            <a:endParaRPr lang="de-TZ"/>
          </a:p>
        </p:txBody>
      </p:sp>
    </p:spTree>
    <p:extLst>
      <p:ext uri="{BB962C8B-B14F-4D97-AF65-F5344CB8AC3E}">
        <p14:creationId xmlns:p14="http://schemas.microsoft.com/office/powerpoint/2010/main" val="35155627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EA174C7-4172-AD55-0209-D0CE598D236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de-TZ"/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D851D79E-B568-4621-371E-3D674D2A59B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TZ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27E73801-4D36-5631-2468-0164C8BBC0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A24BA7-D115-7E4E-9003-74E1D667B184}" type="datetimeFigureOut">
              <a:rPr lang="de-TZ" smtClean="0"/>
              <a:t>11/14/2025</a:t>
            </a:fld>
            <a:endParaRPr lang="de-TZ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79C66216-BDC6-BF02-75D5-A3F069EEFE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TZ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10071ACB-D5E5-568B-EF6E-796C219D27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E72AA4-F2F9-E048-B08F-8E3A8D02451E}" type="slidenum">
              <a:rPr lang="de-TZ" smtClean="0"/>
              <a:t>‹#›</a:t>
            </a:fld>
            <a:endParaRPr lang="de-TZ"/>
          </a:p>
        </p:txBody>
      </p:sp>
    </p:spTree>
    <p:extLst>
      <p:ext uri="{BB962C8B-B14F-4D97-AF65-F5344CB8AC3E}">
        <p14:creationId xmlns:p14="http://schemas.microsoft.com/office/powerpoint/2010/main" val="7528120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955C4E2F-E01B-150C-D965-E0688473683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de-TZ"/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2F0F0079-8531-AABD-C59A-3EBEF15ADBE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TZ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A3146B53-050E-970E-3784-6A79E7D241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A24BA7-D115-7E4E-9003-74E1D667B184}" type="datetimeFigureOut">
              <a:rPr lang="de-TZ" smtClean="0"/>
              <a:t>11/14/2025</a:t>
            </a:fld>
            <a:endParaRPr lang="de-TZ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9FBD1EE1-45C7-8BA5-63E7-8642210756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TZ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D7D04AD8-E000-576F-7C23-5CB826396E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E72AA4-F2F9-E048-B08F-8E3A8D02451E}" type="slidenum">
              <a:rPr lang="de-TZ" smtClean="0"/>
              <a:t>‹#›</a:t>
            </a:fld>
            <a:endParaRPr lang="de-TZ"/>
          </a:p>
        </p:txBody>
      </p:sp>
    </p:spTree>
    <p:extLst>
      <p:ext uri="{BB962C8B-B14F-4D97-AF65-F5344CB8AC3E}">
        <p14:creationId xmlns:p14="http://schemas.microsoft.com/office/powerpoint/2010/main" val="28849424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283D3477-8A85-3B91-743F-A3155F80A34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de-TZ"/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7E64AB3E-68A4-4FFA-03F6-99AD8C81EB2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TZ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E0ECD1BE-F8C2-A8A9-B664-1C5516CEA7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A24BA7-D115-7E4E-9003-74E1D667B184}" type="datetimeFigureOut">
              <a:rPr lang="de-TZ" smtClean="0"/>
              <a:t>11/14/2025</a:t>
            </a:fld>
            <a:endParaRPr lang="de-TZ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84C021AE-3A6D-ADB8-C5E7-8F92107A6A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TZ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0DC6DE07-8D02-BC4D-AC9A-49E7CC5CD8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E72AA4-F2F9-E048-B08F-8E3A8D02451E}" type="slidenum">
              <a:rPr lang="de-TZ" smtClean="0"/>
              <a:t>‹#›</a:t>
            </a:fld>
            <a:endParaRPr lang="de-TZ"/>
          </a:p>
        </p:txBody>
      </p:sp>
    </p:spTree>
    <p:extLst>
      <p:ext uri="{BB962C8B-B14F-4D97-AF65-F5344CB8AC3E}">
        <p14:creationId xmlns:p14="http://schemas.microsoft.com/office/powerpoint/2010/main" val="34822832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97189E09-C65D-C40F-1306-73A575E4ADA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  <a:endParaRPr lang="de-TZ"/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BD32BD65-23F9-9512-9ADD-8F502F3D85D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23177F27-274B-37CB-EF34-12E1A600E1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A24BA7-D115-7E4E-9003-74E1D667B184}" type="datetimeFigureOut">
              <a:rPr lang="de-TZ" smtClean="0"/>
              <a:t>11/14/2025</a:t>
            </a:fld>
            <a:endParaRPr lang="de-TZ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CFB3FF2A-EF30-28C0-DF90-A1EEAC6AEB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TZ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69199F96-D2DB-9AAE-3CAC-0622E88DFB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E72AA4-F2F9-E048-B08F-8E3A8D02451E}" type="slidenum">
              <a:rPr lang="de-TZ" smtClean="0"/>
              <a:t>‹#›</a:t>
            </a:fld>
            <a:endParaRPr lang="de-TZ"/>
          </a:p>
        </p:txBody>
      </p:sp>
    </p:spTree>
    <p:extLst>
      <p:ext uri="{BB962C8B-B14F-4D97-AF65-F5344CB8AC3E}">
        <p14:creationId xmlns:p14="http://schemas.microsoft.com/office/powerpoint/2010/main" val="1368307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CA2F20F6-36E1-8B6D-DF0A-19104A00364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de-TZ"/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4A7F75AC-7ACC-A980-153C-CA77FB1DDC3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TZ"/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DD80B600-FF0A-0982-1F13-E1AD4D2FE0D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TZ"/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50B0DC81-F5FB-B7D9-D876-942C043DB0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A24BA7-D115-7E4E-9003-74E1D667B184}" type="datetimeFigureOut">
              <a:rPr lang="de-TZ" smtClean="0"/>
              <a:t>11/14/2025</a:t>
            </a:fld>
            <a:endParaRPr lang="de-TZ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7C1C7CD0-FDE4-772B-E408-6F8F75E369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TZ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5C98E2E7-8060-2093-3EB7-2508DD1EAD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E72AA4-F2F9-E048-B08F-8E3A8D02451E}" type="slidenum">
              <a:rPr lang="de-TZ" smtClean="0"/>
              <a:t>‹#›</a:t>
            </a:fld>
            <a:endParaRPr lang="de-TZ"/>
          </a:p>
        </p:txBody>
      </p:sp>
    </p:spTree>
    <p:extLst>
      <p:ext uri="{BB962C8B-B14F-4D97-AF65-F5344CB8AC3E}">
        <p14:creationId xmlns:p14="http://schemas.microsoft.com/office/powerpoint/2010/main" val="41411924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8A6FC65-5E7F-C3C9-4942-39531C070A2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de-TZ"/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A2630B1B-4073-A20A-AB73-F60009F7462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F179C7D8-B122-46EA-F8BA-E06518D7E5B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TZ"/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96FE21D1-ED4F-311E-2E0A-488E224DB39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652C27FA-2285-2604-67E0-3572D6DD339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TZ"/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42855DEA-A8E8-CEC7-FF5E-D24143CA04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A24BA7-D115-7E4E-9003-74E1D667B184}" type="datetimeFigureOut">
              <a:rPr lang="de-TZ" smtClean="0"/>
              <a:t>11/14/2025</a:t>
            </a:fld>
            <a:endParaRPr lang="de-TZ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D07C534C-034D-537C-ED7A-38CD8B2FF8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TZ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8136376E-E115-5667-AB0A-AA45CC52EA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E72AA4-F2F9-E048-B08F-8E3A8D02451E}" type="slidenum">
              <a:rPr lang="de-TZ" smtClean="0"/>
              <a:t>‹#›</a:t>
            </a:fld>
            <a:endParaRPr lang="de-TZ"/>
          </a:p>
        </p:txBody>
      </p:sp>
    </p:spTree>
    <p:extLst>
      <p:ext uri="{BB962C8B-B14F-4D97-AF65-F5344CB8AC3E}">
        <p14:creationId xmlns:p14="http://schemas.microsoft.com/office/powerpoint/2010/main" val="22464016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814BCB3-5BB9-CDE2-2D43-05286D4271E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de-TZ"/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BF58CCA3-F1E3-6282-EC15-0A41BDB18F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A24BA7-D115-7E4E-9003-74E1D667B184}" type="datetimeFigureOut">
              <a:rPr lang="de-TZ" smtClean="0"/>
              <a:t>11/14/2025</a:t>
            </a:fld>
            <a:endParaRPr lang="de-TZ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B87C7DDD-95E0-A31D-3CE3-BFE6F2FD7B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TZ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B2BFC4D9-FA55-720A-D57F-2B47E9A034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E72AA4-F2F9-E048-B08F-8E3A8D02451E}" type="slidenum">
              <a:rPr lang="de-TZ" smtClean="0"/>
              <a:t>‹#›</a:t>
            </a:fld>
            <a:endParaRPr lang="de-TZ"/>
          </a:p>
        </p:txBody>
      </p:sp>
    </p:spTree>
    <p:extLst>
      <p:ext uri="{BB962C8B-B14F-4D97-AF65-F5344CB8AC3E}">
        <p14:creationId xmlns:p14="http://schemas.microsoft.com/office/powerpoint/2010/main" val="27485522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13BDD10C-7364-5E4A-A8ED-9612429998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A24BA7-D115-7E4E-9003-74E1D667B184}" type="datetimeFigureOut">
              <a:rPr lang="de-TZ" smtClean="0"/>
              <a:t>11/14/2025</a:t>
            </a:fld>
            <a:endParaRPr lang="de-TZ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56C3319A-5E7C-6643-9056-A4466A48E1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TZ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D6D3DD87-47A5-512E-DFA8-38397334DA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E72AA4-F2F9-E048-B08F-8E3A8D02451E}" type="slidenum">
              <a:rPr lang="de-TZ" smtClean="0"/>
              <a:t>‹#›</a:t>
            </a:fld>
            <a:endParaRPr lang="de-TZ"/>
          </a:p>
        </p:txBody>
      </p:sp>
    </p:spTree>
    <p:extLst>
      <p:ext uri="{BB962C8B-B14F-4D97-AF65-F5344CB8AC3E}">
        <p14:creationId xmlns:p14="http://schemas.microsoft.com/office/powerpoint/2010/main" val="4666396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6BA6538F-72F8-158E-25B0-172FB625848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  <a:endParaRPr lang="de-TZ"/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730654FF-DE08-3A4E-2735-320561EADD7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TZ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BB3E6FE2-81F9-0C17-1AF7-BD904EF1680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9B7EF35C-9AAA-C85D-A9CA-A270B7C7B5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A24BA7-D115-7E4E-9003-74E1D667B184}" type="datetimeFigureOut">
              <a:rPr lang="de-TZ" smtClean="0"/>
              <a:t>11/14/2025</a:t>
            </a:fld>
            <a:endParaRPr lang="de-TZ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93895F17-3E2F-4860-3482-B48DE43A84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TZ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61E0C450-BFBA-0440-693B-FFFFD7AB20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E72AA4-F2F9-E048-B08F-8E3A8D02451E}" type="slidenum">
              <a:rPr lang="de-TZ" smtClean="0"/>
              <a:t>‹#›</a:t>
            </a:fld>
            <a:endParaRPr lang="de-TZ"/>
          </a:p>
        </p:txBody>
      </p:sp>
    </p:spTree>
    <p:extLst>
      <p:ext uri="{BB962C8B-B14F-4D97-AF65-F5344CB8AC3E}">
        <p14:creationId xmlns:p14="http://schemas.microsoft.com/office/powerpoint/2010/main" val="41120761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DA728C45-1B32-6FA7-FA4B-5B37E36D6AE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  <a:endParaRPr lang="de-TZ"/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9DFDB24A-450A-3F04-CA9D-7E358C917D8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TZ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35E04C82-AF95-9673-B5D4-2BB23CAD3C2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17DA5BE0-E2D6-CA3D-CF18-2F7C491B20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A24BA7-D115-7E4E-9003-74E1D667B184}" type="datetimeFigureOut">
              <a:rPr lang="de-TZ" smtClean="0"/>
              <a:t>11/14/2025</a:t>
            </a:fld>
            <a:endParaRPr lang="de-TZ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F7934749-BB0C-B75D-5FF1-3D1BCC7A15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TZ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84C9A1E0-924F-0022-95A0-8CD13209B2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E72AA4-F2F9-E048-B08F-8E3A8D02451E}" type="slidenum">
              <a:rPr lang="de-TZ" smtClean="0"/>
              <a:t>‹#›</a:t>
            </a:fld>
            <a:endParaRPr lang="de-TZ"/>
          </a:p>
        </p:txBody>
      </p:sp>
    </p:spTree>
    <p:extLst>
      <p:ext uri="{BB962C8B-B14F-4D97-AF65-F5344CB8AC3E}">
        <p14:creationId xmlns:p14="http://schemas.microsoft.com/office/powerpoint/2010/main" val="22828801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AFADF27D-8285-02C7-8417-E6D7A6EE074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de-TZ"/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2916C8E4-DE34-7FFA-3E32-47831E239B3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TZ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080FA948-C81C-6E6C-3983-CCDC65DAD07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A24BA7-D115-7E4E-9003-74E1D667B184}" type="datetimeFigureOut">
              <a:rPr lang="de-TZ" smtClean="0"/>
              <a:t>11/14/2025</a:t>
            </a:fld>
            <a:endParaRPr lang="de-TZ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F54888C6-AEC9-D4A5-66A1-EAABEA28176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TZ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0435F86E-3B69-B1E0-8CCF-7225FAC50BC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E72AA4-F2F9-E048-B08F-8E3A8D02451E}" type="slidenum">
              <a:rPr lang="de-TZ" smtClean="0"/>
              <a:t>‹#›</a:t>
            </a:fld>
            <a:endParaRPr lang="de-TZ"/>
          </a:p>
        </p:txBody>
      </p:sp>
    </p:spTree>
    <p:extLst>
      <p:ext uri="{BB962C8B-B14F-4D97-AF65-F5344CB8AC3E}">
        <p14:creationId xmlns:p14="http://schemas.microsoft.com/office/powerpoint/2010/main" val="20122821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TZ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Abgerundetes Rechteck 5">
            <a:extLst>
              <a:ext uri="{FF2B5EF4-FFF2-40B4-BE49-F238E27FC236}">
                <a16:creationId xmlns:a16="http://schemas.microsoft.com/office/drawing/2014/main" id="{61CD7981-8EF3-1C1E-844A-AC2683FB43D6}"/>
              </a:ext>
            </a:extLst>
          </p:cNvPr>
          <p:cNvSpPr/>
          <p:nvPr/>
        </p:nvSpPr>
        <p:spPr>
          <a:xfrm>
            <a:off x="4439798" y="121187"/>
            <a:ext cx="3205908" cy="640813"/>
          </a:xfrm>
          <a:prstGeom prst="round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TZ" sz="1400" b="1" dirty="0"/>
              <a:t>Mobile laboratory deployment:</a:t>
            </a:r>
          </a:p>
          <a:p>
            <a:pPr algn="ctr"/>
            <a:r>
              <a:rPr lang="de-TZ" sz="1400" dirty="0"/>
              <a:t>From NPHL/Nairobi to GCRH/MSCH</a:t>
            </a:r>
          </a:p>
        </p:txBody>
      </p:sp>
      <p:sp>
        <p:nvSpPr>
          <p:cNvPr id="7" name="Abgerundetes Rechteck 6">
            <a:extLst>
              <a:ext uri="{FF2B5EF4-FFF2-40B4-BE49-F238E27FC236}">
                <a16:creationId xmlns:a16="http://schemas.microsoft.com/office/drawing/2014/main" id="{B2531CD9-AD3F-8574-98D6-78055BDC88CA}"/>
              </a:ext>
            </a:extLst>
          </p:cNvPr>
          <p:cNvSpPr/>
          <p:nvPr/>
        </p:nvSpPr>
        <p:spPr>
          <a:xfrm>
            <a:off x="4098274" y="886627"/>
            <a:ext cx="3811836" cy="960303"/>
          </a:xfrm>
          <a:prstGeom prst="round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TZ" sz="1400" b="1" dirty="0"/>
              <a:t>Consultations at Hospital: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de-TZ" sz="1400" dirty="0"/>
              <a:t>Mobile laboratory team lead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de-TZ" sz="1400" dirty="0"/>
              <a:t>Director of Public Health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de-TZ" sz="1400" dirty="0"/>
              <a:t>County Medical Laboratory Coordinator </a:t>
            </a:r>
          </a:p>
        </p:txBody>
      </p:sp>
      <p:sp>
        <p:nvSpPr>
          <p:cNvPr id="8" name="Abgerundetes Rechteck 7">
            <a:extLst>
              <a:ext uri="{FF2B5EF4-FFF2-40B4-BE49-F238E27FC236}">
                <a16:creationId xmlns:a16="http://schemas.microsoft.com/office/drawing/2014/main" id="{8A3630D3-0B44-147E-1AA2-8AB0929727CB}"/>
              </a:ext>
            </a:extLst>
          </p:cNvPr>
          <p:cNvSpPr/>
          <p:nvPr/>
        </p:nvSpPr>
        <p:spPr>
          <a:xfrm>
            <a:off x="3148987" y="2001394"/>
            <a:ext cx="2544897" cy="466380"/>
          </a:xfrm>
          <a:prstGeom prst="round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TZ" sz="1400" b="1" dirty="0"/>
              <a:t>Identify room</a:t>
            </a:r>
          </a:p>
        </p:txBody>
      </p:sp>
      <p:sp>
        <p:nvSpPr>
          <p:cNvPr id="9" name="Abgerundetes Rechteck 8">
            <a:extLst>
              <a:ext uri="{FF2B5EF4-FFF2-40B4-BE49-F238E27FC236}">
                <a16:creationId xmlns:a16="http://schemas.microsoft.com/office/drawing/2014/main" id="{74437A92-DC13-498F-EF08-5D30AAF90E3C}"/>
              </a:ext>
            </a:extLst>
          </p:cNvPr>
          <p:cNvSpPr/>
          <p:nvPr/>
        </p:nvSpPr>
        <p:spPr>
          <a:xfrm>
            <a:off x="6220857" y="2001394"/>
            <a:ext cx="3033312" cy="934599"/>
          </a:xfrm>
          <a:prstGeom prst="round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TZ" sz="1400" b="1" dirty="0"/>
              <a:t>County health center outreach team: 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de-TZ" sz="1400" dirty="0"/>
              <a:t>Mobile laboratory team lead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de-TZ" sz="1400" dirty="0"/>
              <a:t>County Medical Laboratory Coordinator</a:t>
            </a:r>
          </a:p>
        </p:txBody>
      </p:sp>
      <p:sp>
        <p:nvSpPr>
          <p:cNvPr id="10" name="Abgerundetes Rechteck 9">
            <a:extLst>
              <a:ext uri="{FF2B5EF4-FFF2-40B4-BE49-F238E27FC236}">
                <a16:creationId xmlns:a16="http://schemas.microsoft.com/office/drawing/2014/main" id="{92A2627E-E245-26FD-758B-4C37E2251B5F}"/>
              </a:ext>
            </a:extLst>
          </p:cNvPr>
          <p:cNvSpPr/>
          <p:nvPr/>
        </p:nvSpPr>
        <p:spPr>
          <a:xfrm>
            <a:off x="3148985" y="2581487"/>
            <a:ext cx="2544897" cy="466380"/>
          </a:xfrm>
          <a:prstGeom prst="round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TZ" sz="1400" b="1" dirty="0"/>
              <a:t>Mobile laboratory set-up </a:t>
            </a:r>
          </a:p>
          <a:p>
            <a:pPr algn="ctr"/>
            <a:r>
              <a:rPr lang="de-TZ" sz="1400" dirty="0"/>
              <a:t>(pre-/post-PCR rooms)</a:t>
            </a:r>
          </a:p>
        </p:txBody>
      </p:sp>
      <p:sp>
        <p:nvSpPr>
          <p:cNvPr id="11" name="Abgerundetes Rechteck 10">
            <a:extLst>
              <a:ext uri="{FF2B5EF4-FFF2-40B4-BE49-F238E27FC236}">
                <a16:creationId xmlns:a16="http://schemas.microsoft.com/office/drawing/2014/main" id="{6D73CBF2-D15E-FA98-EB9E-3EE321CB7867}"/>
              </a:ext>
            </a:extLst>
          </p:cNvPr>
          <p:cNvSpPr/>
          <p:nvPr/>
        </p:nvSpPr>
        <p:spPr>
          <a:xfrm>
            <a:off x="3148985" y="3170627"/>
            <a:ext cx="2544897" cy="722126"/>
          </a:xfrm>
          <a:prstGeom prst="round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TZ" sz="1400" b="1" dirty="0"/>
              <a:t>Quality check:</a:t>
            </a:r>
          </a:p>
          <a:p>
            <a:pPr algn="ctr"/>
            <a:r>
              <a:rPr lang="de-TZ" sz="1400" dirty="0"/>
              <a:t>process PCR positive and negative mock sample</a:t>
            </a:r>
          </a:p>
        </p:txBody>
      </p:sp>
      <p:sp>
        <p:nvSpPr>
          <p:cNvPr id="12" name="Abgerundetes Rechteck 11">
            <a:extLst>
              <a:ext uri="{FF2B5EF4-FFF2-40B4-BE49-F238E27FC236}">
                <a16:creationId xmlns:a16="http://schemas.microsoft.com/office/drawing/2014/main" id="{79B91C59-CCD9-F16B-94DE-DE6E5009E660}"/>
              </a:ext>
            </a:extLst>
          </p:cNvPr>
          <p:cNvSpPr/>
          <p:nvPr/>
        </p:nvSpPr>
        <p:spPr>
          <a:xfrm>
            <a:off x="3148984" y="4023446"/>
            <a:ext cx="2544897" cy="765670"/>
          </a:xfrm>
          <a:prstGeom prst="round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TZ" sz="1400" b="1" dirty="0"/>
              <a:t>Expand pool of operators:</a:t>
            </a:r>
          </a:p>
          <a:p>
            <a:pPr algn="ctr"/>
            <a:r>
              <a:rPr lang="de-TZ" sz="1400" dirty="0"/>
              <a:t>train two local laboratory experts</a:t>
            </a:r>
          </a:p>
        </p:txBody>
      </p:sp>
      <p:sp>
        <p:nvSpPr>
          <p:cNvPr id="13" name="Abgerundetes Rechteck 12">
            <a:extLst>
              <a:ext uri="{FF2B5EF4-FFF2-40B4-BE49-F238E27FC236}">
                <a16:creationId xmlns:a16="http://schemas.microsoft.com/office/drawing/2014/main" id="{02B1E28B-50BC-4597-28F1-900B1D5BB9A9}"/>
              </a:ext>
            </a:extLst>
          </p:cNvPr>
          <p:cNvSpPr/>
          <p:nvPr/>
        </p:nvSpPr>
        <p:spPr>
          <a:xfrm>
            <a:off x="3148983" y="4933648"/>
            <a:ext cx="2544897" cy="765670"/>
          </a:xfrm>
          <a:prstGeom prst="round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TZ" sz="1400" b="1" dirty="0"/>
              <a:t>Mobile laboratory at deployment site operational</a:t>
            </a:r>
            <a:endParaRPr lang="de-TZ" sz="1400" dirty="0"/>
          </a:p>
        </p:txBody>
      </p:sp>
      <p:sp>
        <p:nvSpPr>
          <p:cNvPr id="14" name="Abgerundetes Rechteck 13">
            <a:extLst>
              <a:ext uri="{FF2B5EF4-FFF2-40B4-BE49-F238E27FC236}">
                <a16:creationId xmlns:a16="http://schemas.microsoft.com/office/drawing/2014/main" id="{59DC8583-5728-39B3-A1AB-905A843A9356}"/>
              </a:ext>
            </a:extLst>
          </p:cNvPr>
          <p:cNvSpPr/>
          <p:nvPr/>
        </p:nvSpPr>
        <p:spPr>
          <a:xfrm>
            <a:off x="6220857" y="3115936"/>
            <a:ext cx="3033312" cy="1688995"/>
          </a:xfrm>
          <a:prstGeom prst="round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TZ" sz="1400" b="1" dirty="0"/>
              <a:t>Virtual and physical briefing of peripheral health centers: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GB" sz="1400" kern="100" dirty="0">
                <a:solidFill>
                  <a:schemeClr val="bg1"/>
                </a:solidFill>
                <a:effectLst/>
                <a:ea typeface="DengXian" panose="02010600030101010101" pitchFamily="2" charset="-122"/>
              </a:rPr>
              <a:t>observe patient flow and screening activities 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GB" sz="1400" kern="100" dirty="0">
                <a:solidFill>
                  <a:schemeClr val="bg1"/>
                </a:solidFill>
                <a:effectLst/>
                <a:ea typeface="DengXian" panose="02010600030101010101" pitchFamily="2" charset="-122"/>
              </a:rPr>
              <a:t>create awareness of mobile laboratory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GB" sz="1400" kern="100" dirty="0">
                <a:solidFill>
                  <a:schemeClr val="bg1"/>
                </a:solidFill>
                <a:effectLst/>
                <a:ea typeface="DengXian" panose="02010600030101010101" pitchFamily="2" charset="-122"/>
              </a:rPr>
              <a:t>ensure referral of all malaria negative samples</a:t>
            </a:r>
            <a:endParaRPr lang="de-TZ" sz="1400" b="1" dirty="0">
              <a:solidFill>
                <a:schemeClr val="bg1"/>
              </a:solidFill>
            </a:endParaRPr>
          </a:p>
        </p:txBody>
      </p:sp>
      <p:sp>
        <p:nvSpPr>
          <p:cNvPr id="15" name="Abgerundetes Rechteck 14">
            <a:extLst>
              <a:ext uri="{FF2B5EF4-FFF2-40B4-BE49-F238E27FC236}">
                <a16:creationId xmlns:a16="http://schemas.microsoft.com/office/drawing/2014/main" id="{2014BD51-4842-B4C0-8C00-DA8F143643B1}"/>
              </a:ext>
            </a:extLst>
          </p:cNvPr>
          <p:cNvSpPr/>
          <p:nvPr/>
        </p:nvSpPr>
        <p:spPr>
          <a:xfrm>
            <a:off x="6220857" y="4933648"/>
            <a:ext cx="3033312" cy="765670"/>
          </a:xfrm>
          <a:prstGeom prst="round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TZ" sz="1400" b="1" dirty="0"/>
              <a:t>County-wide sample referral system operational</a:t>
            </a:r>
            <a:endParaRPr lang="de-TZ" sz="1400" dirty="0"/>
          </a:p>
        </p:txBody>
      </p:sp>
      <p:sp>
        <p:nvSpPr>
          <p:cNvPr id="16" name="Abgerundetes Rechteck 15">
            <a:extLst>
              <a:ext uri="{FF2B5EF4-FFF2-40B4-BE49-F238E27FC236}">
                <a16:creationId xmlns:a16="http://schemas.microsoft.com/office/drawing/2014/main" id="{C0A38704-BE66-8002-2B3D-A49BB6B17511}"/>
              </a:ext>
            </a:extLst>
          </p:cNvPr>
          <p:cNvSpPr/>
          <p:nvPr/>
        </p:nvSpPr>
        <p:spPr>
          <a:xfrm>
            <a:off x="4190082" y="5956455"/>
            <a:ext cx="3811836" cy="646324"/>
          </a:xfrm>
          <a:prstGeom prst="round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TZ" sz="1400" b="1" dirty="0"/>
              <a:t>Diagnose referred patient samples in the mobile laboratory</a:t>
            </a:r>
            <a:endParaRPr lang="de-TZ" sz="1400" dirty="0"/>
          </a:p>
        </p:txBody>
      </p:sp>
      <p:sp>
        <p:nvSpPr>
          <p:cNvPr id="17" name="Pfeil nach unten 16">
            <a:extLst>
              <a:ext uri="{FF2B5EF4-FFF2-40B4-BE49-F238E27FC236}">
                <a16:creationId xmlns:a16="http://schemas.microsoft.com/office/drawing/2014/main" id="{D329EF79-6341-BC7A-5802-1DAF1CA886BC}"/>
              </a:ext>
            </a:extLst>
          </p:cNvPr>
          <p:cNvSpPr/>
          <p:nvPr/>
        </p:nvSpPr>
        <p:spPr>
          <a:xfrm flipH="1">
            <a:off x="5794872" y="784034"/>
            <a:ext cx="418641" cy="77118"/>
          </a:xfrm>
          <a:prstGeom prst="downArrow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TZ"/>
          </a:p>
        </p:txBody>
      </p:sp>
      <p:sp>
        <p:nvSpPr>
          <p:cNvPr id="18" name="Pfeil nach unten 17">
            <a:extLst>
              <a:ext uri="{FF2B5EF4-FFF2-40B4-BE49-F238E27FC236}">
                <a16:creationId xmlns:a16="http://schemas.microsoft.com/office/drawing/2014/main" id="{83F46614-B986-33F9-91A0-4D20317D8EDE}"/>
              </a:ext>
            </a:extLst>
          </p:cNvPr>
          <p:cNvSpPr/>
          <p:nvPr/>
        </p:nvSpPr>
        <p:spPr>
          <a:xfrm flipH="1">
            <a:off x="7423532" y="1883884"/>
            <a:ext cx="418641" cy="77118"/>
          </a:xfrm>
          <a:prstGeom prst="downArrow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TZ"/>
          </a:p>
        </p:txBody>
      </p:sp>
      <p:sp>
        <p:nvSpPr>
          <p:cNvPr id="19" name="Pfeil nach unten 18">
            <a:extLst>
              <a:ext uri="{FF2B5EF4-FFF2-40B4-BE49-F238E27FC236}">
                <a16:creationId xmlns:a16="http://schemas.microsoft.com/office/drawing/2014/main" id="{00F1E17A-0DD0-40EA-F210-C6AF2BD4CA65}"/>
              </a:ext>
            </a:extLst>
          </p:cNvPr>
          <p:cNvSpPr/>
          <p:nvPr/>
        </p:nvSpPr>
        <p:spPr>
          <a:xfrm flipH="1">
            <a:off x="4204765" y="1893063"/>
            <a:ext cx="418641" cy="77118"/>
          </a:xfrm>
          <a:prstGeom prst="downArrow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TZ"/>
          </a:p>
        </p:txBody>
      </p:sp>
      <p:sp>
        <p:nvSpPr>
          <p:cNvPr id="20" name="Pfeil nach unten 19">
            <a:extLst>
              <a:ext uri="{FF2B5EF4-FFF2-40B4-BE49-F238E27FC236}">
                <a16:creationId xmlns:a16="http://schemas.microsoft.com/office/drawing/2014/main" id="{5197FC11-A254-8408-6289-A10881083F02}"/>
              </a:ext>
            </a:extLst>
          </p:cNvPr>
          <p:cNvSpPr/>
          <p:nvPr/>
        </p:nvSpPr>
        <p:spPr>
          <a:xfrm flipH="1">
            <a:off x="4213944" y="2486140"/>
            <a:ext cx="418641" cy="77118"/>
          </a:xfrm>
          <a:prstGeom prst="downArrow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TZ"/>
          </a:p>
        </p:txBody>
      </p:sp>
      <p:sp>
        <p:nvSpPr>
          <p:cNvPr id="21" name="Pfeil nach unten 20">
            <a:extLst>
              <a:ext uri="{FF2B5EF4-FFF2-40B4-BE49-F238E27FC236}">
                <a16:creationId xmlns:a16="http://schemas.microsoft.com/office/drawing/2014/main" id="{EC600B1A-F047-A7A9-D8E5-533D5D48FBE3}"/>
              </a:ext>
            </a:extLst>
          </p:cNvPr>
          <p:cNvSpPr/>
          <p:nvPr/>
        </p:nvSpPr>
        <p:spPr>
          <a:xfrm flipH="1">
            <a:off x="4223123" y="3068069"/>
            <a:ext cx="418641" cy="77118"/>
          </a:xfrm>
          <a:prstGeom prst="downArrow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TZ"/>
          </a:p>
        </p:txBody>
      </p:sp>
      <p:sp>
        <p:nvSpPr>
          <p:cNvPr id="22" name="Pfeil nach unten 21">
            <a:extLst>
              <a:ext uri="{FF2B5EF4-FFF2-40B4-BE49-F238E27FC236}">
                <a16:creationId xmlns:a16="http://schemas.microsoft.com/office/drawing/2014/main" id="{B30433B4-4184-9142-199D-DBBE4558F2B9}"/>
              </a:ext>
            </a:extLst>
          </p:cNvPr>
          <p:cNvSpPr/>
          <p:nvPr/>
        </p:nvSpPr>
        <p:spPr>
          <a:xfrm flipH="1">
            <a:off x="4221285" y="3925681"/>
            <a:ext cx="418641" cy="77118"/>
          </a:xfrm>
          <a:prstGeom prst="downArrow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TZ"/>
          </a:p>
        </p:txBody>
      </p:sp>
      <p:sp>
        <p:nvSpPr>
          <p:cNvPr id="23" name="Pfeil nach unten 22">
            <a:extLst>
              <a:ext uri="{FF2B5EF4-FFF2-40B4-BE49-F238E27FC236}">
                <a16:creationId xmlns:a16="http://schemas.microsoft.com/office/drawing/2014/main" id="{6B3F8192-0A93-2C47-EA16-CDFA004CDDED}"/>
              </a:ext>
            </a:extLst>
          </p:cNvPr>
          <p:cNvSpPr/>
          <p:nvPr/>
        </p:nvSpPr>
        <p:spPr>
          <a:xfrm flipH="1">
            <a:off x="4230464" y="4826966"/>
            <a:ext cx="418641" cy="77118"/>
          </a:xfrm>
          <a:prstGeom prst="downArrow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TZ"/>
          </a:p>
        </p:txBody>
      </p:sp>
      <p:sp>
        <p:nvSpPr>
          <p:cNvPr id="24" name="Pfeil nach unten 23">
            <a:extLst>
              <a:ext uri="{FF2B5EF4-FFF2-40B4-BE49-F238E27FC236}">
                <a16:creationId xmlns:a16="http://schemas.microsoft.com/office/drawing/2014/main" id="{63528B64-5A09-2A1A-3DD9-63D2E1D58B4E}"/>
              </a:ext>
            </a:extLst>
          </p:cNvPr>
          <p:cNvSpPr/>
          <p:nvPr/>
        </p:nvSpPr>
        <p:spPr>
          <a:xfrm flipH="1">
            <a:off x="7423531" y="3006955"/>
            <a:ext cx="418641" cy="77118"/>
          </a:xfrm>
          <a:prstGeom prst="downArrow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TZ"/>
          </a:p>
        </p:txBody>
      </p:sp>
      <p:sp>
        <p:nvSpPr>
          <p:cNvPr id="25" name="Pfeil nach unten 24">
            <a:extLst>
              <a:ext uri="{FF2B5EF4-FFF2-40B4-BE49-F238E27FC236}">
                <a16:creationId xmlns:a16="http://schemas.microsoft.com/office/drawing/2014/main" id="{33629F45-2768-FE33-6971-EFBB1EAC5D3C}"/>
              </a:ext>
            </a:extLst>
          </p:cNvPr>
          <p:cNvSpPr/>
          <p:nvPr/>
        </p:nvSpPr>
        <p:spPr>
          <a:xfrm flipH="1">
            <a:off x="7454744" y="4819108"/>
            <a:ext cx="418641" cy="77118"/>
          </a:xfrm>
          <a:prstGeom prst="downArrow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TZ"/>
          </a:p>
        </p:txBody>
      </p:sp>
      <p:sp>
        <p:nvSpPr>
          <p:cNvPr id="26" name="Pfeil nach unten 25">
            <a:extLst>
              <a:ext uri="{FF2B5EF4-FFF2-40B4-BE49-F238E27FC236}">
                <a16:creationId xmlns:a16="http://schemas.microsoft.com/office/drawing/2014/main" id="{9AB9529A-D3DE-3E02-EC70-AD24AA6186FD}"/>
              </a:ext>
            </a:extLst>
          </p:cNvPr>
          <p:cNvSpPr/>
          <p:nvPr/>
        </p:nvSpPr>
        <p:spPr>
          <a:xfrm flipH="1">
            <a:off x="7432711" y="5759992"/>
            <a:ext cx="418641" cy="77118"/>
          </a:xfrm>
          <a:prstGeom prst="downArrow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TZ"/>
          </a:p>
        </p:txBody>
      </p:sp>
      <p:sp>
        <p:nvSpPr>
          <p:cNvPr id="27" name="Pfeil nach unten 26">
            <a:extLst>
              <a:ext uri="{FF2B5EF4-FFF2-40B4-BE49-F238E27FC236}">
                <a16:creationId xmlns:a16="http://schemas.microsoft.com/office/drawing/2014/main" id="{50C8EB27-4811-1331-82B0-81A4CEF0BE69}"/>
              </a:ext>
            </a:extLst>
          </p:cNvPr>
          <p:cNvSpPr/>
          <p:nvPr/>
        </p:nvSpPr>
        <p:spPr>
          <a:xfrm flipH="1">
            <a:off x="4213944" y="5769171"/>
            <a:ext cx="418641" cy="77118"/>
          </a:xfrm>
          <a:prstGeom prst="downArrow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TZ"/>
          </a:p>
        </p:txBody>
      </p:sp>
    </p:spTree>
    <p:extLst>
      <p:ext uri="{BB962C8B-B14F-4D97-AF65-F5344CB8AC3E}">
        <p14:creationId xmlns:p14="http://schemas.microsoft.com/office/powerpoint/2010/main" val="31085497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15</Words>
  <Application>Microsoft Office PowerPoint</Application>
  <PresentationFormat>Widescreen</PresentationFormat>
  <Paragraphs>2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DengXian</vt:lpstr>
      <vt:lpstr>Offic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icrosoft Office User</dc:creator>
  <cp:lastModifiedBy>Aprilyn Decipolo Deguit</cp:lastModifiedBy>
  <cp:revision>7</cp:revision>
  <dcterms:created xsi:type="dcterms:W3CDTF">2025-07-30T06:56:12Z</dcterms:created>
  <dcterms:modified xsi:type="dcterms:W3CDTF">2025-11-14T10:36:25Z</dcterms:modified>
</cp:coreProperties>
</file>